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66" r:id="rId4"/>
    <p:sldId id="267" r:id="rId5"/>
    <p:sldId id="269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th, Kevin" initials="RK" lastIdx="0" clrIdx="0">
    <p:extLst>
      <p:ext uri="{19B8F6BF-5375-455C-9EA6-DF929625EA0E}">
        <p15:presenceInfo xmlns:p15="http://schemas.microsoft.com/office/powerpoint/2012/main" userId="Roth, Kevi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7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39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ADCC8-2AB7-4F4A-BEA7-22DACDBBEC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30D0ECA-1810-48DC-98BC-59E51948DD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72137D-B92F-4367-9096-3BF8DFD24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24C139-0851-4E9A-9515-B70D12B34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4A3B8E-75F9-4448-B23E-3358CD695D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0101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2AB22C-C489-4230-8872-482D63881F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7D6BDC-D484-4F46-9734-320F3D1827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381311-B873-4BAC-A4EF-492C25D8A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42E1AE-DB76-4B47-8DCF-E262DA461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FB5D61-2342-425C-BB3B-E5B8F453F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7347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98BCB7-4992-4175-A58F-6F866CF003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083B42-C5C0-4228-B183-E7459C2D1A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CF1915-A697-41F3-BD7A-5FDA23F25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C42650-750B-4EFE-B89C-6BC2C5522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B067FD-5285-41A9-8A32-721CF9537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973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ECB128-553B-4CF1-92D0-F670B650A4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666977-2BA5-4210-B3F7-375964E22F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2CD346-8D05-4300-8525-96086651E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E95A93-DFAB-4DFD-B245-DBF7322B8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E63FA9-67D7-412C-B21D-21C063490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1031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9AD89-9A1C-43AD-ADA7-DCDDCB8581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0E1819-0826-4258-8E71-5B1296AD2B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AB45D7-C169-4726-995B-FD26237BD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517250-907A-4452-82A7-2981E49D5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AC9194-1EB3-42D4-9D1C-9A9BA353E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4382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CD165E-FEAF-4450-9220-E996ED5F71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A46C8B-2BE1-45C5-B07F-2A4585B139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ACFFE3-619A-4DA4-9CAE-39B4154984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632412-3CF8-44DC-A9F3-991BF51D6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494270-B959-402B-ADC3-ACC7C9DD0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EA741B-4062-448A-A931-718CC7741E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9092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8AE31C-386D-4AA3-9859-7E49D42D7C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4C4127-BBE1-4F4B-8B1D-FBB30B9A02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673A03-3BE1-4E4A-B4B3-F5AB3DFD59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C87A1C-6CE4-4192-A9FB-C592602356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4ABF713-2C2A-4BA9-9199-B14943F157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7AD7CA3-C62C-4718-91D6-151CC8C8A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FE209E7-B553-4CD8-9B53-B0433D495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A7B461A-25F4-4A96-945A-67C6A6796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9448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DE4B8F-D330-4E21-B95D-77F054CA57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519C6CC-2019-4519-88E3-822E569C3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F341A7-530C-4EA0-B214-8428C6FAB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FB5B25C-74EA-4991-B34E-668D79F6D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9868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6197186-D4E6-407B-8719-5CF2BB2AD9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8EF203-76A1-4435-AE0A-1AD8DAC48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BCF4D6-1573-4A27-8EEA-D78DECD4E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5966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A0E895-B59A-4C6E-97B6-41AE65290A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AB2FCB-CAFD-4BF7-9536-CF1F89D7C3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463E7E-1DE9-4E7F-BB11-353450E85C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F374E5-BDA4-48C6-8C79-4E574B93D6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566343-96F0-4929-9584-CF79948DD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6AA3D9-D019-45D0-85C1-66B349830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6963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4F931F-DD90-41B2-BE9A-38D36051CC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B897EA6-CD4A-4DE8-AA88-26611DF754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3BACB7-2E41-4C96-A3B8-76CA1D17E5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01F0C2-202C-4349-8B5A-198E78DB6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270504-292D-489F-93B9-97650ADCE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6CED1C-6C18-445B-8678-908BB9888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075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A5DAE4A-2250-496C-A04D-EDA8A33EDE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BE0BF8-78EB-482C-ADC0-B0D773B983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EFA962-EE8E-424C-9F85-39272E57F5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76DE6-4E47-4FE2-9A66-F34022BE862F}" type="datetimeFigureOut">
              <a:rPr lang="de-DE" smtClean="0"/>
              <a:t>12.01.21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5E9B01-A5C7-4E24-B449-015C3B91F7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0316A5-AEDB-487A-B3A9-10BD2835B7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EF9CB-FFE5-41C6-8860-4DB2402DEC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5818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81CD764-EAB9-4153-95CB-2643D1156E91}"/>
              </a:ext>
            </a:extLst>
          </p:cNvPr>
          <p:cNvSpPr txBox="1"/>
          <p:nvPr/>
        </p:nvSpPr>
        <p:spPr>
          <a:xfrm>
            <a:off x="151003" y="198836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A1BFBD8-515D-4594-909E-42467D0B3F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4230" y="1437404"/>
            <a:ext cx="5023539" cy="45053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8156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81CD764-EAB9-4153-95CB-2643D1156E91}"/>
              </a:ext>
            </a:extLst>
          </p:cNvPr>
          <p:cNvSpPr txBox="1"/>
          <p:nvPr/>
        </p:nvSpPr>
        <p:spPr>
          <a:xfrm>
            <a:off x="151003" y="198836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5BDFCCB-9237-4717-A93E-59460FEEE1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4602" y="692844"/>
            <a:ext cx="7268908" cy="5712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19126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81CD764-EAB9-4153-95CB-2643D1156E91}"/>
              </a:ext>
            </a:extLst>
          </p:cNvPr>
          <p:cNvSpPr txBox="1"/>
          <p:nvPr/>
        </p:nvSpPr>
        <p:spPr>
          <a:xfrm>
            <a:off x="151003" y="198836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D0289F4E-AD25-477A-92DD-A3806328497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1956" y="791580"/>
            <a:ext cx="7068088" cy="55546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466347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81CD764-EAB9-4153-95CB-2643D1156E91}"/>
              </a:ext>
            </a:extLst>
          </p:cNvPr>
          <p:cNvSpPr txBox="1"/>
          <p:nvPr/>
        </p:nvSpPr>
        <p:spPr>
          <a:xfrm>
            <a:off x="151003" y="198836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D966B512-CB83-4531-93D1-F29FCCA5EF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7881" y="499529"/>
            <a:ext cx="7065991" cy="58589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777295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81CD764-EAB9-4153-95CB-2643D1156E91}"/>
              </a:ext>
            </a:extLst>
          </p:cNvPr>
          <p:cNvSpPr txBox="1"/>
          <p:nvPr/>
        </p:nvSpPr>
        <p:spPr>
          <a:xfrm>
            <a:off x="151003" y="198836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83C16830-0FB0-4DE4-AC09-E623FC00EFB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9860" y="939350"/>
            <a:ext cx="7061249" cy="55493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81722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5</Words>
  <Application>Microsoft Macintosh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Roth (PG Research)</dc:creator>
  <cp:lastModifiedBy>Microsoft Office User</cp:lastModifiedBy>
  <cp:revision>36</cp:revision>
  <dcterms:created xsi:type="dcterms:W3CDTF">2020-04-01T12:38:34Z</dcterms:created>
  <dcterms:modified xsi:type="dcterms:W3CDTF">2021-01-12T11:27:15Z</dcterms:modified>
</cp:coreProperties>
</file>